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200" d="100"/>
          <a:sy n="200" d="100"/>
        </p:scale>
        <p:origin x="474" y="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8590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3996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755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7089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410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7175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1606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4465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3246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1266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576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D1323-8F1D-4CAD-86FD-1EE347AB59D6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2E0947-FD47-42A6-A6BA-A45783F810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1222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>
            <a:extLst>
              <a:ext uri="{FF2B5EF4-FFF2-40B4-BE49-F238E27FC236}">
                <a16:creationId xmlns:a16="http://schemas.microsoft.com/office/drawing/2014/main" id="{654AE8EF-6CB1-5FC8-69B6-8B3B33AEFAE9}"/>
              </a:ext>
            </a:extLst>
          </p:cNvPr>
          <p:cNvSpPr/>
          <p:nvPr/>
        </p:nvSpPr>
        <p:spPr>
          <a:xfrm>
            <a:off x="536527" y="335831"/>
            <a:ext cx="5784945" cy="22486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1200"/>
              </a:spcAft>
            </a:pP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arative transcriptomic with UPLC-Q-</a:t>
            </a:r>
            <a:r>
              <a:rPr lang="en-US" altLang="zh-CN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active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S reveals differences in gene expression and components of iridoid biosynthesis in various parts of </a:t>
            </a:r>
            <a:r>
              <a:rPr lang="en-US" altLang="zh-CN" b="1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tiana</a:t>
            </a:r>
          </a:p>
          <a:p>
            <a:pPr>
              <a:lnSpc>
                <a:spcPct val="150000"/>
              </a:lnSpc>
              <a:spcAft>
                <a:spcPts val="1200"/>
              </a:spcAft>
            </a:pPr>
            <a:r>
              <a:rPr lang="en-US" altLang="zh-CN" b="1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crophylla.</a:t>
            </a:r>
          </a:p>
          <a:p>
            <a:pPr>
              <a:lnSpc>
                <a:spcPct val="150000"/>
              </a:lnSpc>
              <a:spcAft>
                <a:spcPts val="1200"/>
              </a:spcAft>
            </a:pPr>
            <a:endParaRPr lang="zh-CN" altLang="zh-CN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6D10BCC-0493-41A3-901E-415EA7ABC710}"/>
              </a:ext>
            </a:extLst>
          </p:cNvPr>
          <p:cNvSpPr txBox="1"/>
          <p:nvPr/>
        </p:nvSpPr>
        <p:spPr>
          <a:xfrm>
            <a:off x="493664" y="2319338"/>
            <a:ext cx="6364336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0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uhang</a:t>
            </a:r>
            <a: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ou</a:t>
            </a:r>
            <a:r>
              <a:rPr lang="en-US" altLang="zh-CN" sz="1000" b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0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Xiaoying</a:t>
            </a:r>
            <a: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i</a:t>
            </a:r>
            <a:r>
              <a:rPr lang="en-US" altLang="zh-CN" sz="1000" b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0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Zhuo</a:t>
            </a:r>
            <a: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</a:t>
            </a:r>
            <a:r>
              <a:rPr lang="en-US" altLang="zh-CN" sz="1000" b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Yun </a:t>
            </a:r>
            <a:r>
              <a:rPr lang="en-US" altLang="zh-CN" sz="10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i</a:t>
            </a:r>
            <a:r>
              <a:rPr lang="en-US" altLang="zh-CN" sz="1000" b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0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*, Siting Ma</a:t>
            </a:r>
            <a:r>
              <a:rPr lang="en-US" altLang="zh-CN" sz="10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0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ianliang</a:t>
            </a:r>
            <a: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en</a:t>
            </a:r>
            <a:r>
              <a:rPr lang="en-US" altLang="zh-CN" sz="1000" b="1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,b</a:t>
            </a:r>
            <a:r>
              <a:rPr lang="en-US" altLang="zh-CN" sz="10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altLang="zh-CN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*</a:t>
            </a:r>
          </a:p>
          <a:p>
            <a:pPr>
              <a:lnSpc>
                <a:spcPct val="150000"/>
              </a:lnSpc>
            </a:pPr>
            <a:endParaRPr lang="en-US" altLang="zh-C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College of Life Sciences, Northwest University, Xi’an 710069, China</a:t>
            </a:r>
          </a:p>
          <a:p>
            <a:pPr>
              <a:lnSpc>
                <a:spcPct val="150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Biomedicine Key Laboratory of Shaanxi Province, Northwest University, Xi’an 710069, China</a:t>
            </a:r>
          </a:p>
          <a:p>
            <a:pPr>
              <a:lnSpc>
                <a:spcPct val="150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Xi'an Institute for Food and Drug Control, Xi’an 710054, China</a:t>
            </a:r>
          </a:p>
          <a:p>
            <a:pPr>
              <a:lnSpc>
                <a:spcPct val="150000"/>
              </a:lnSpc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Correspondence: aiyun-vip@163.com; cql999999@126.com</a:t>
            </a:r>
          </a:p>
          <a:p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07307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96665BC8-4EA4-FAD0-69AB-613EE7BBA575}"/>
              </a:ext>
            </a:extLst>
          </p:cNvPr>
          <p:cNvSpPr/>
          <p:nvPr/>
        </p:nvSpPr>
        <p:spPr>
          <a:xfrm>
            <a:off x="1837265" y="3501692"/>
            <a:ext cx="363831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he principal components analysis (PCA) analysis of four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arts of </a:t>
            </a:r>
            <a:r>
              <a:rPr lang="en-US" altLang="zh-CN" sz="1000" i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. macrophylla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7C11B22-5FB0-7B79-D45D-CB52C7F54B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7265" y="630652"/>
            <a:ext cx="3527931" cy="26459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60592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3481087-7723-C813-9952-5D27BF53AA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26468"/>
            <a:ext cx="6858000" cy="4312763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9D4405CC-7FC4-C030-ADFC-3E5E34A256F6}"/>
              </a:ext>
            </a:extLst>
          </p:cNvPr>
          <p:cNvSpPr/>
          <p:nvPr/>
        </p:nvSpPr>
        <p:spPr>
          <a:xfrm>
            <a:off x="1548884" y="4829889"/>
            <a:ext cx="439725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he expression of six key enzyme genes (</a:t>
            </a:r>
            <a:r>
              <a:rPr lang="en-US" altLang="zh-CN" sz="10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R, GPPS, G8O, SLS, 7-DLGT, and 7-DLH</a:t>
            </a:r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by transcriptome  analysis of G. macrophylla. </a:t>
            </a:r>
            <a:endParaRPr lang="zh-CN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6043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</TotalTime>
  <Words>147</Words>
  <Application>Microsoft Office PowerPoint</Application>
  <PresentationFormat>A4 Paper (210x297 mm)</PresentationFormat>
  <Paragraphs>1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imes New Roman</vt:lpstr>
      <vt:lpstr>Office 主题​​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MDPI-12</cp:lastModifiedBy>
  <cp:revision>8</cp:revision>
  <dcterms:created xsi:type="dcterms:W3CDTF">2022-07-20T08:04:23Z</dcterms:created>
  <dcterms:modified xsi:type="dcterms:W3CDTF">2022-12-15T14:59:14Z</dcterms:modified>
</cp:coreProperties>
</file>